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1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72" y="31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05954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12374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73182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05860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26600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89114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96625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22066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24136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1911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98764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2A6FD1-E976-4A46-A689-E519C14A9596}" type="datetimeFigureOut">
              <a:rPr lang="de-CH" smtClean="0"/>
              <a:t>27.05.2021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88583-F284-45DC-ACCB-365B413C499D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56071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1363" y="1044668"/>
            <a:ext cx="9891827" cy="4433104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9149675F-3235-426A-AE5C-40219E0637B7}"/>
              </a:ext>
            </a:extLst>
          </p:cNvPr>
          <p:cNvSpPr txBox="1"/>
          <p:nvPr/>
        </p:nvSpPr>
        <p:spPr>
          <a:xfrm>
            <a:off x="1006679" y="499276"/>
            <a:ext cx="79627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Figure S1: Location of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s4353135, rs55646866 and rs10733113713</a:t>
            </a:r>
            <a:endParaRPr lang="de-CH" b="1" dirty="0"/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16802A4A-B747-4F34-B1F0-2DFE94BE5C10}"/>
              </a:ext>
            </a:extLst>
          </p:cNvPr>
          <p:cNvSpPr txBox="1"/>
          <p:nvPr/>
        </p:nvSpPr>
        <p:spPr>
          <a:xfrm>
            <a:off x="894697" y="5653832"/>
            <a:ext cx="100884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Location of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s4353135 (red), rs55646866 (green) and rs10733113713 (blue) on chromosome 1, downstream </a:t>
            </a:r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f NLRP3 </a:t>
            </a:r>
            <a:r>
              <a:rPr lang="en-US">
                <a:latin typeface="Times New Roman" panose="02020603050405020304" pitchFamily="18" charset="0"/>
              </a:rPr>
              <a:t>and </a:t>
            </a:r>
            <a:r>
              <a:rPr lang="en-US" dirty="0">
                <a:latin typeface="Times New Roman" panose="02020603050405020304" pitchFamily="18" charset="0"/>
              </a:rPr>
              <a:t>upstream/within OR2B11</a:t>
            </a:r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746798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Breitbild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sabelle Frey-Wagner</dc:creator>
  <cp:lastModifiedBy>Isabelle Frey-Wagner</cp:lastModifiedBy>
  <cp:revision>4</cp:revision>
  <cp:lastPrinted>2021-05-27T13:05:11Z</cp:lastPrinted>
  <dcterms:created xsi:type="dcterms:W3CDTF">2021-05-27T13:05:00Z</dcterms:created>
  <dcterms:modified xsi:type="dcterms:W3CDTF">2021-05-27T20:13:22Z</dcterms:modified>
</cp:coreProperties>
</file>